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854"/>
    <p:restoredTop sz="94668"/>
  </p:normalViewPr>
  <p:slideViewPr>
    <p:cSldViewPr snapToGrid="0">
      <p:cViewPr>
        <p:scale>
          <a:sx n="141" d="100"/>
          <a:sy n="141" d="100"/>
        </p:scale>
        <p:origin x="1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B2D7BA-2B32-F827-95F5-BBEEF106CC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ED1D7F0-B8B1-FDB4-1FB2-EEB1A94272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6BBD77-5E28-A0C3-57CD-F33EA024AE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9FE4DC-046B-F7BD-66CB-EBEED6BC9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5FDC5B-5685-F5AB-BE49-0DEE43139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7052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4AC759-8B9A-4922-430F-73D9E279D6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763714F-B7E9-6042-6D2F-8A70778448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23A695-B836-92BA-54C0-20286FA42A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09B734-04F6-40C2-395A-9448B6153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C447EB-0BF2-9924-F68D-FB46474D0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1327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69A8B5D-BC14-71A2-1B6F-30DEE25638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265101B-C8D9-96B0-3D34-7EEF015BD2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0A7677-2B12-FECD-6987-160B19961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7184CB-1D1F-3136-00F9-0028E5493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2C4466-D1C5-D80D-6A91-323D7B47A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378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A6142B-1303-A506-9113-FC26D2E18D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6D9FF79-FD8B-81A7-631B-CF220034EA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3BE8EBD-856D-6344-E740-3CB24BE5C7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2A7D2C-18EA-283C-F428-C165A75FDA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ED4C0D-868E-B58C-D56E-76CB4721A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0110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12346B-B6BF-24FE-B02A-8405576AC6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A8BE7DC-E3F7-D509-7A49-0523FC5576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E69A57-A3A7-AAAD-D424-0AFFCCDDE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461F5E-6ACB-82B5-4A92-45B0265BFF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5DABFC-9B28-3D35-B182-BB8523A8C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1089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FC04A9-174C-3332-F7F0-E82DC3C098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5470334-4094-24F4-6212-E1A15C16FD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9BCC11F-0F31-8F4F-61CC-1B01215F4B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549595D-D6AB-3E11-6D86-5F335A7B9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589D015-504F-8871-429B-CBA169A48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FAC16F3-620D-17F2-3C67-12D47C8A9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1203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AAE4FE-347B-7004-B635-CA67F9A1AB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F95A4C0-1BD6-72B5-C622-8219E23D6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64B45C9-2E5E-F14A-7CFC-314DBB7675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52AFEF7-3E52-1007-9A6C-F5342B10F2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C15A1E2-A38E-8364-9106-835FE9FE68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8BCEA27-E0CD-F821-66C4-3E8FB7A7A4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8348B80-FA50-C1B8-8118-18A9C01A0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520E466-8D99-3C7F-A6CF-D5159902F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2916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729675-F845-FA56-A599-52F13DB5C2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542F620-5458-4F97-B499-2FB86D20E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B76F73A-00F3-AFE0-CB15-EBB54FD87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095FA97-6B0B-E35F-4EFC-D0B5C6329B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6884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D604BC7-DAAF-CC69-198C-1647A7BB51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1611978-AAED-1872-1BA2-ED62DA6C1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BE891A8-7AE5-4200-4920-B222ECFB2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4339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C4182F-0D64-444F-A4E3-435F2E5E9C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3083963-22B6-2F25-C212-DBFFCF14EC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4642315-2832-BB0C-65E3-64C5517B27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750FE4D-5B7F-CC40-81E3-F5A7A2A98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988C719-B553-3840-CE3B-ABB61329B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6DC8B09-4C69-FB4D-A66D-03369D346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8166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79315B-F14B-D11E-0F7C-6DC63B2EA5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2F685A7-255E-6379-BD34-32D090FF3D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0EEA917-4A67-105D-D6FF-35315BA91C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DF694A0-637D-1098-3C2A-225E43810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643D99D-5B90-9189-CD24-8D0BD7207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C0346FF-5E89-2260-B9F6-0D9E8998E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0868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5CE17FE-9E97-724C-08BF-DE7A98E585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B8F87F5-75B2-0D41-B229-9EC5A1CB57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054318-9210-D980-2CBA-36DF18580D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4B799F-2368-4240-86A7-2C59026C2FFD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BF86C5-E7F3-76ED-6A3C-B26187A603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332001-34C1-14FA-FDDC-1F9C5FA511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44FC78-5B56-4A4A-B53B-C58152BCB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2962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://www.mbkbase.org/" TargetMode="Externa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1056000" y="973235"/>
            <a:ext cx="10080000" cy="2704520"/>
            <a:chOff x="483506" y="1130145"/>
            <a:chExt cx="10903024" cy="2925339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71CDB73B-F650-0C4B-BF27-5915037802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4689"/>
            <a:stretch/>
          </p:blipFill>
          <p:spPr>
            <a:xfrm>
              <a:off x="586530" y="1603414"/>
              <a:ext cx="10800000" cy="1739652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6A898D6B-32DA-EA3A-E4A8-B743506BE2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87010" r="2488" b="3171"/>
            <a:stretch/>
          </p:blipFill>
          <p:spPr>
            <a:xfrm>
              <a:off x="947130" y="3326942"/>
              <a:ext cx="10180216" cy="200132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A809F3C-8E98-B652-C765-6D908EA1A0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76811" r="2422" b="1082"/>
            <a:stretch/>
          </p:blipFill>
          <p:spPr>
            <a:xfrm>
              <a:off x="483506" y="3549981"/>
              <a:ext cx="10643840" cy="505503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82792546-03D0-36EE-B2B5-AE69CCA0D0D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901135" y="1130145"/>
              <a:ext cx="6120000" cy="429759"/>
            </a:xfrm>
            <a:prstGeom prst="rect">
              <a:avLst/>
            </a:prstGeom>
          </p:spPr>
        </p:pic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6FEF7726-AB1E-9918-8635-03856EE3C543}"/>
              </a:ext>
            </a:extLst>
          </p:cNvPr>
          <p:cNvSpPr txBox="1"/>
          <p:nvPr/>
        </p:nvSpPr>
        <p:spPr>
          <a:xfrm>
            <a:off x="946673" y="4452150"/>
            <a:ext cx="10298654" cy="9079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attern of candidate genes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ABT1.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profiles in various tissues at different developmental ages or cells, and the data were obtained from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6"/>
              </a:rPr>
              <a:t>http://www.mbkbase.org/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PKM, Fragments Per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lobas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Million, indicates gene expression level. Milk, filling and mature represent the developmental stages of rice grain. G-ale indicates grain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euron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cates grain embryo and g-ES indicates grain endosperm.</a:t>
            </a:r>
          </a:p>
        </p:txBody>
      </p:sp>
    </p:spTree>
    <p:extLst>
      <p:ext uri="{BB962C8B-B14F-4D97-AF65-F5344CB8AC3E}">
        <p14:creationId xmlns:p14="http://schemas.microsoft.com/office/powerpoint/2010/main" val="1602814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5</TotalTime>
  <Words>78</Words>
  <Application>Microsoft Macintosh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大普</dc:creator>
  <cp:lastModifiedBy>Microsoft Office 用户</cp:lastModifiedBy>
  <cp:revision>79</cp:revision>
  <dcterms:created xsi:type="dcterms:W3CDTF">2022-07-14T10:21:33Z</dcterms:created>
  <dcterms:modified xsi:type="dcterms:W3CDTF">2022-07-30T12:36:00Z</dcterms:modified>
</cp:coreProperties>
</file>